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56" r:id="rId4"/>
    <p:sldId id="261" r:id="rId5"/>
    <p:sldId id="263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9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941D6C-82E8-4AAD-8D3C-BB930B3DD7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DE9FAA-DAE7-4E09-B5B6-C47E1BF720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C89EB-04EA-4CC0-AFE1-9600E0373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2A2A2-C863-44A5-8F43-4A1BD8693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64CA8B-D12F-44B8-BF16-CF504B0FF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022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E9D06C-BCFE-4037-A140-E02A3422E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04A108-7286-4C2A-8A36-89719833CC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4B51A4-1855-4989-B30F-D888682B2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4DCC7-3949-4CED-B4B6-2BF63B582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C96BC6-C510-4077-90B2-FFAC4343A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837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FFD0AF-9BE3-4DBB-BFCC-80BADF8A24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7B30BA-5824-46FA-8997-3E6C73CCC4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B7AB3-BF7F-400D-B1A3-C62935A2C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812A4C-468A-476E-BCEA-E8601319A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EEC71-FBD5-4E93-8849-DFD256664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25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38299-4A90-4B48-BFF7-815E16B52D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796108-4B60-4166-B00B-A3B4B22719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F4D682-D4F2-4EC7-94FB-D38A0DC93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0F1D91-DD49-4685-8202-7DCA743FC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E641E5-1EAE-4CE4-8979-116E6E829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145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6A038F-0052-4893-AFE6-095B02B68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C27F4A-0F7C-4ECA-864B-D22D798F0F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614DE0-EBF8-4349-8499-A56A4AA42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A1F48-04CB-425F-BE10-1D8366F69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75662-6A77-4A74-B0B1-8D365B03E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474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4F38A-4568-4E9E-98AD-ECA170A35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BF3033-AFD4-4575-8954-62AE00C426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6FE8F0-C09A-4C2D-8BC0-258719DC8D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3AD4D2-D929-4879-8261-90762B290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AAD809-468E-4BF9-BB3F-E9734CB41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B31CA2-AB4F-4F52-A7DD-FEF35E0EB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778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56F457-819F-4987-B4E8-2F695D8766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B30ED3-51D7-4F28-85A5-C3145729DE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CAA814-3EA9-42AE-AD52-EFBB32EDF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03DEF-15FA-4AFB-95BF-A16ABC0DDA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61F167-5EF8-4608-9274-D4F3AD78BC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04C5A0-A7F4-4B3B-BDAF-708D19ABA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A17F4F-52A5-473B-9EA6-5814E96ED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345B26-4C90-495B-AB23-345D9A4AE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768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FC9199-AE3A-44EF-B209-262F31314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D5DDE2-0C17-41C9-9F1B-B7898641E5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3B7D21-B6A2-4C65-AC11-6E435CC41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E9D438-DA88-41E2-A5AA-B7BFD9A36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638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A2C343E-9E52-4337-8130-5558AD700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E6DD4DB-8591-4218-8AB3-7892B65E5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6D519B-2ABB-460B-96AB-439B79800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185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8A1C8-4F0B-4D73-8220-035B3C7BB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1F6DEC-B194-4A8A-A0E0-7A5D7C96CF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14DFB1-8C2E-4268-A9EE-F6B394A8EF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CABE24-98CB-4F22-B52C-496D02C19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F3DFAE-6C72-498D-A45B-A3965504E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887BCB-9485-41EA-89F9-C77B654D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595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8064EF-1233-4B49-9A0B-6AA908C50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E69A8F-E4D2-4A67-B773-75F3A1E47F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010BF7-1F32-4E09-9DE2-2C5C211B88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395BE3-8025-4CC0-8AA6-40B0E1755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03CEFA-1966-4EFD-A4F4-56C31917D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6B0CC7-42C6-469A-852C-C04470A18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284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7E3DAD-416C-4C6F-94D1-532A51BA80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B2CC3F-DDD3-4738-B4B4-8B4033183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CB92F7-5B39-4DB5-A9E0-FC02FD6BD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7B36D-2EB2-42BA-A45D-C58AF6A1D533}" type="datetimeFigureOut">
              <a:rPr lang="en-US" smtClean="0"/>
              <a:t>6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B8A0BC-980C-497C-90D3-FFAFECA5FB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1B8F8C-692A-4FC8-8A70-9B467F1EB6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F1D3C-2042-4FD6-B483-40335415E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838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package" Target="../embeddings/Microsoft_Excel_Worksheet1.xlsx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E54FBB1-3B14-4E86-B139-EA7597B1E0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1114659"/>
              </p:ext>
            </p:extLst>
          </p:nvPr>
        </p:nvGraphicFramePr>
        <p:xfrm>
          <a:off x="568171" y="1221237"/>
          <a:ext cx="10848511" cy="4247618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426769">
                  <a:extLst>
                    <a:ext uri="{9D8B030D-6E8A-4147-A177-3AD203B41FA5}">
                      <a16:colId xmlns:a16="http://schemas.microsoft.com/office/drawing/2014/main" val="603287433"/>
                    </a:ext>
                  </a:extLst>
                </a:gridCol>
                <a:gridCol w="1207266">
                  <a:extLst>
                    <a:ext uri="{9D8B030D-6E8A-4147-A177-3AD203B41FA5}">
                      <a16:colId xmlns:a16="http://schemas.microsoft.com/office/drawing/2014/main" val="3787043629"/>
                    </a:ext>
                  </a:extLst>
                </a:gridCol>
                <a:gridCol w="1283248">
                  <a:extLst>
                    <a:ext uri="{9D8B030D-6E8A-4147-A177-3AD203B41FA5}">
                      <a16:colId xmlns:a16="http://schemas.microsoft.com/office/drawing/2014/main" val="3466587332"/>
                    </a:ext>
                  </a:extLst>
                </a:gridCol>
                <a:gridCol w="1249478">
                  <a:extLst>
                    <a:ext uri="{9D8B030D-6E8A-4147-A177-3AD203B41FA5}">
                      <a16:colId xmlns:a16="http://schemas.microsoft.com/office/drawing/2014/main" val="3396740969"/>
                    </a:ext>
                  </a:extLst>
                </a:gridCol>
                <a:gridCol w="1731188">
                  <a:extLst>
                    <a:ext uri="{9D8B030D-6E8A-4147-A177-3AD203B41FA5}">
                      <a16:colId xmlns:a16="http://schemas.microsoft.com/office/drawing/2014/main" val="187805643"/>
                    </a:ext>
                  </a:extLst>
                </a:gridCol>
                <a:gridCol w="1988598">
                  <a:extLst>
                    <a:ext uri="{9D8B030D-6E8A-4147-A177-3AD203B41FA5}">
                      <a16:colId xmlns:a16="http://schemas.microsoft.com/office/drawing/2014/main" val="1134341996"/>
                    </a:ext>
                  </a:extLst>
                </a:gridCol>
                <a:gridCol w="1961964">
                  <a:extLst>
                    <a:ext uri="{9D8B030D-6E8A-4147-A177-3AD203B41FA5}">
                      <a16:colId xmlns:a16="http://schemas.microsoft.com/office/drawing/2014/main" val="2517989490"/>
                    </a:ext>
                  </a:extLst>
                </a:gridCol>
              </a:tblGrid>
              <a:tr h="1237877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</a:rPr>
                        <a:t>Reference SNP</a:t>
                      </a:r>
                      <a:endParaRPr lang="de-DE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</a:rPr>
                        <a:t>Position</a:t>
                      </a:r>
                      <a:endParaRPr lang="de-DE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Base Variation</a:t>
                      </a:r>
                      <a:endParaRPr lang="de-DE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Gene Name</a:t>
                      </a:r>
                      <a:endParaRPr lang="de-DE" sz="16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 err="1">
                          <a:effectLst/>
                        </a:rPr>
                        <a:t>Chromosome</a:t>
                      </a:r>
                      <a:endParaRPr lang="de-DE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Minor Allele Frequency 1000Genomes Global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</a:rPr>
                        <a:t>Minor Allele Frequency Study Population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4039353156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rs10741668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1527738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[A/G]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?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hr 11, p14.1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A = 0.29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A = 0.32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1306432692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rs10790334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9889593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[T/C]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?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hr 11, q14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 = 0.18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C = 0.3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3051681201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rs2065418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30400521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[T/G]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MPPED2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hr 11, p14.1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G = 0.27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G = 0.35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3506865484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rs3098223 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103434877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[A/G]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DCAF1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hr 8, q22.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G = 0.48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G = 0.46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3223176295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rs3134287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103411258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[T/C]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SLC25A32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hr 8, q22.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C = 0.48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C = 0.46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4022805024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rs2241777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103400160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[A/C]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SLC25A32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Chr 8, q22.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>
                          <a:effectLst/>
                        </a:rPr>
                        <a:t>A = 0.43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</a:rPr>
                        <a:t>A = 0.46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2562667484"/>
                  </a:ext>
                </a:extLst>
              </a:tr>
              <a:tr h="42996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rs906790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76161264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[T/C]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</a:rPr>
                        <a:t>?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 err="1">
                          <a:effectLst/>
                        </a:rPr>
                        <a:t>Chr</a:t>
                      </a:r>
                      <a:r>
                        <a:rPr lang="de-DE" sz="1600" u="none" strike="noStrike" dirty="0">
                          <a:effectLst/>
                        </a:rPr>
                        <a:t> 13, q21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T = 0.31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</a:rPr>
                        <a:t>T = 0.43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2036" marR="12036" marT="12036" marB="0" anchor="ctr"/>
                </a:tc>
                <a:extLst>
                  <a:ext uri="{0D108BD9-81ED-4DB2-BD59-A6C34878D82A}">
                    <a16:rowId xmlns:a16="http://schemas.microsoft.com/office/drawing/2014/main" val="31133678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D7D06B2-1890-4DDA-B784-0FE364DEBDA5}"/>
              </a:ext>
            </a:extLst>
          </p:cNvPr>
          <p:cNvSpPr txBox="1"/>
          <p:nvPr/>
        </p:nvSpPr>
        <p:spPr>
          <a:xfrm>
            <a:off x="363984" y="257452"/>
            <a:ext cx="2849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</p:spTree>
    <p:extLst>
      <p:ext uri="{BB962C8B-B14F-4D97-AF65-F5344CB8AC3E}">
        <p14:creationId xmlns:p14="http://schemas.microsoft.com/office/powerpoint/2010/main" val="26853717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BDB5DA1-4827-401E-8008-7BBBBDE425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9288789"/>
              </p:ext>
            </p:extLst>
          </p:nvPr>
        </p:nvGraphicFramePr>
        <p:xfrm>
          <a:off x="1198832" y="1163609"/>
          <a:ext cx="9794335" cy="4530782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218506">
                  <a:extLst>
                    <a:ext uri="{9D8B030D-6E8A-4147-A177-3AD203B41FA5}">
                      <a16:colId xmlns:a16="http://schemas.microsoft.com/office/drawing/2014/main" val="1716748567"/>
                    </a:ext>
                  </a:extLst>
                </a:gridCol>
                <a:gridCol w="1793290">
                  <a:extLst>
                    <a:ext uri="{9D8B030D-6E8A-4147-A177-3AD203B41FA5}">
                      <a16:colId xmlns:a16="http://schemas.microsoft.com/office/drawing/2014/main" val="748822860"/>
                    </a:ext>
                  </a:extLst>
                </a:gridCol>
                <a:gridCol w="1792155">
                  <a:extLst>
                    <a:ext uri="{9D8B030D-6E8A-4147-A177-3AD203B41FA5}">
                      <a16:colId xmlns:a16="http://schemas.microsoft.com/office/drawing/2014/main" val="229081266"/>
                    </a:ext>
                  </a:extLst>
                </a:gridCol>
                <a:gridCol w="1998956">
                  <a:extLst>
                    <a:ext uri="{9D8B030D-6E8A-4147-A177-3AD203B41FA5}">
                      <a16:colId xmlns:a16="http://schemas.microsoft.com/office/drawing/2014/main" val="159127588"/>
                    </a:ext>
                  </a:extLst>
                </a:gridCol>
                <a:gridCol w="1829104">
                  <a:extLst>
                    <a:ext uri="{9D8B030D-6E8A-4147-A177-3AD203B41FA5}">
                      <a16:colId xmlns:a16="http://schemas.microsoft.com/office/drawing/2014/main" val="2903667116"/>
                    </a:ext>
                  </a:extLst>
                </a:gridCol>
                <a:gridCol w="1162324">
                  <a:extLst>
                    <a:ext uri="{9D8B030D-6E8A-4147-A177-3AD203B41FA5}">
                      <a16:colId xmlns:a16="http://schemas.microsoft.com/office/drawing/2014/main" val="1207325503"/>
                    </a:ext>
                  </a:extLst>
                </a:gridCol>
              </a:tblGrid>
              <a:tr h="1031763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906790 TC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 2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2065418 TT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 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0790334 TT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10741668 AA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de-DE" sz="16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97812141"/>
                  </a:ext>
                </a:extLst>
              </a:tr>
              <a:tr h="107298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(</a:t>
                      </a:r>
                      <a:r>
                        <a:rPr lang="de-DE" sz="16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ars</a:t>
                      </a:r>
                      <a:r>
                        <a:rPr lang="de-DE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de-DE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9 ± 3.4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9 ± 7.5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3 ± 6 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6 ± 3.8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070230359"/>
                  </a:ext>
                </a:extLst>
              </a:tr>
              <a:tr h="107298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S</a:t>
                      </a:r>
                      <a:endParaRPr lang="de-DE" sz="1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5 ± 1.7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 ± 4.8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6 ± 2.5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 ± 1.6</a:t>
                      </a:r>
                      <a:endParaRPr lang="de-DE" sz="1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de-DE" sz="1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564135058"/>
                  </a:ext>
                </a:extLst>
              </a:tr>
              <a:tr h="1353059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de-DE" sz="16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: 6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: 14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: 2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: 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: 6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: 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: 6</a:t>
                      </a:r>
                    </a:p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: 1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635068846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05BAFE2-5992-462B-87F1-1250FDBE9C11}"/>
              </a:ext>
            </a:extLst>
          </p:cNvPr>
          <p:cNvSpPr txBox="1"/>
          <p:nvPr/>
        </p:nvSpPr>
        <p:spPr>
          <a:xfrm>
            <a:off x="363984" y="257452"/>
            <a:ext cx="2849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</a:p>
        </p:txBody>
      </p:sp>
    </p:spTree>
    <p:extLst>
      <p:ext uri="{BB962C8B-B14F-4D97-AF65-F5344CB8AC3E}">
        <p14:creationId xmlns:p14="http://schemas.microsoft.com/office/powerpoint/2010/main" val="7986618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AE64715-2243-44A8-B2C9-B92D8E2859D7}"/>
              </a:ext>
            </a:extLst>
          </p:cNvPr>
          <p:cNvSpPr txBox="1"/>
          <p:nvPr/>
        </p:nvSpPr>
        <p:spPr>
          <a:xfrm>
            <a:off x="363984" y="257452"/>
            <a:ext cx="2849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3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BFB9381-ECF9-4174-9083-108F8DC5E8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0382808"/>
              </p:ext>
            </p:extLst>
          </p:nvPr>
        </p:nvGraphicFramePr>
        <p:xfrm>
          <a:off x="861134" y="1455938"/>
          <a:ext cx="10440140" cy="4096545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610035">
                  <a:extLst>
                    <a:ext uri="{9D8B030D-6E8A-4147-A177-3AD203B41FA5}">
                      <a16:colId xmlns:a16="http://schemas.microsoft.com/office/drawing/2014/main" val="721179901"/>
                    </a:ext>
                  </a:extLst>
                </a:gridCol>
                <a:gridCol w="2610035">
                  <a:extLst>
                    <a:ext uri="{9D8B030D-6E8A-4147-A177-3AD203B41FA5}">
                      <a16:colId xmlns:a16="http://schemas.microsoft.com/office/drawing/2014/main" val="525700905"/>
                    </a:ext>
                  </a:extLst>
                </a:gridCol>
                <a:gridCol w="2610035">
                  <a:extLst>
                    <a:ext uri="{9D8B030D-6E8A-4147-A177-3AD203B41FA5}">
                      <a16:colId xmlns:a16="http://schemas.microsoft.com/office/drawing/2014/main" val="95551057"/>
                    </a:ext>
                  </a:extLst>
                </a:gridCol>
                <a:gridCol w="2610035">
                  <a:extLst>
                    <a:ext uri="{9D8B030D-6E8A-4147-A177-3AD203B41FA5}">
                      <a16:colId xmlns:a16="http://schemas.microsoft.com/office/drawing/2014/main" val="4125713851"/>
                    </a:ext>
                  </a:extLst>
                </a:gridCol>
              </a:tblGrid>
              <a:tr h="634921">
                <a:tc>
                  <a:txBody>
                    <a:bodyPr/>
                    <a:lstStyle/>
                    <a:p>
                      <a:pPr algn="ctr"/>
                      <a:endParaRPr lang="en-US" sz="16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rs2065418 TT</a:t>
                      </a:r>
                    </a:p>
                    <a:p>
                      <a:pPr algn="ctr"/>
                      <a:r>
                        <a:rPr lang="en-US" sz="1600" b="1" dirty="0"/>
                        <a:t>n= 16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Control</a:t>
                      </a:r>
                    </a:p>
                    <a:p>
                      <a:pPr algn="ctr"/>
                      <a:r>
                        <a:rPr lang="en-US" sz="1600" b="1" dirty="0"/>
                        <a:t>n= 2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p-value</a:t>
                      </a:r>
                      <a:endParaRPr lang="en-US" sz="1600" i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55339467"/>
                  </a:ext>
                </a:extLst>
              </a:tr>
              <a:tr h="634921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/>
                        <a:t>Age (years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9.6 ± 1.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49.5 ± 1.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&gt;0.9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02392880"/>
                  </a:ext>
                </a:extLst>
              </a:tr>
              <a:tr h="634921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/>
                        <a:t>IS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8.2 ± 0.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18.8 ± 0.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0.5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05856693"/>
                  </a:ext>
                </a:extLst>
              </a:tr>
              <a:tr h="1095891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/>
                        <a:t>Gende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Female: 55</a:t>
                      </a:r>
                    </a:p>
                    <a:p>
                      <a:pPr algn="ctr"/>
                      <a:r>
                        <a:rPr lang="en-US" sz="1600" dirty="0"/>
                        <a:t>Male: 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Female: 65</a:t>
                      </a:r>
                    </a:p>
                    <a:p>
                      <a:pPr algn="ctr"/>
                      <a:r>
                        <a:rPr lang="en-US" sz="1600" dirty="0"/>
                        <a:t>Male: 17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0.1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93613114"/>
                  </a:ext>
                </a:extLst>
              </a:tr>
              <a:tr h="1095891"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/>
                        <a:t>Ethnicity*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Caucasian: 147</a:t>
                      </a:r>
                    </a:p>
                    <a:p>
                      <a:pPr algn="ctr"/>
                      <a:r>
                        <a:rPr lang="en-US" sz="1600" dirty="0"/>
                        <a:t>African-American: 7</a:t>
                      </a:r>
                    </a:p>
                    <a:p>
                      <a:pPr algn="ctr"/>
                      <a:r>
                        <a:rPr lang="en-US" sz="1600" dirty="0"/>
                        <a:t>Asian: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Caucasian: 239</a:t>
                      </a:r>
                    </a:p>
                    <a:p>
                      <a:pPr algn="ctr"/>
                      <a:r>
                        <a:rPr lang="en-US" sz="1600" dirty="0"/>
                        <a:t>African-American: 4</a:t>
                      </a:r>
                    </a:p>
                    <a:p>
                      <a:pPr algn="ctr"/>
                      <a:r>
                        <a:rPr lang="en-US" sz="1600" dirty="0"/>
                        <a:t>Asian: 2</a:t>
                      </a:r>
                    </a:p>
                    <a:p>
                      <a:pPr algn="ctr"/>
                      <a:endParaRPr lang="en-US" sz="16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/>
                        <a:t>0.2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255119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746751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B971D5F-2F40-4D5F-87DA-3152347E07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948190"/>
              </p:ext>
            </p:extLst>
          </p:nvPr>
        </p:nvGraphicFramePr>
        <p:xfrm>
          <a:off x="876000" y="1380727"/>
          <a:ext cx="10440000" cy="4096545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610000">
                  <a:extLst>
                    <a:ext uri="{9D8B030D-6E8A-4147-A177-3AD203B41FA5}">
                      <a16:colId xmlns:a16="http://schemas.microsoft.com/office/drawing/2014/main" val="721179901"/>
                    </a:ext>
                  </a:extLst>
                </a:gridCol>
                <a:gridCol w="2610000">
                  <a:extLst>
                    <a:ext uri="{9D8B030D-6E8A-4147-A177-3AD203B41FA5}">
                      <a16:colId xmlns:a16="http://schemas.microsoft.com/office/drawing/2014/main" val="525700905"/>
                    </a:ext>
                  </a:extLst>
                </a:gridCol>
                <a:gridCol w="3035800">
                  <a:extLst>
                    <a:ext uri="{9D8B030D-6E8A-4147-A177-3AD203B41FA5}">
                      <a16:colId xmlns:a16="http://schemas.microsoft.com/office/drawing/2014/main" val="95551057"/>
                    </a:ext>
                  </a:extLst>
                </a:gridCol>
                <a:gridCol w="2184200">
                  <a:extLst>
                    <a:ext uri="{9D8B030D-6E8A-4147-A177-3AD203B41FA5}">
                      <a16:colId xmlns:a16="http://schemas.microsoft.com/office/drawing/2014/main" val="4125713851"/>
                    </a:ext>
                  </a:extLst>
                </a:gridCol>
              </a:tblGrid>
              <a:tr h="634921">
                <a:tc>
                  <a:txBody>
                    <a:bodyPr/>
                    <a:lstStyle/>
                    <a:p>
                      <a:pPr algn="ctr"/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2065418 TT high ISS</a:t>
                      </a:r>
                    </a:p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 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high ISS</a:t>
                      </a:r>
                    </a:p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 5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4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55339467"/>
                  </a:ext>
                </a:extLst>
              </a:tr>
              <a:tr h="634921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(years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5 ± 3.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 ± 2.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02392880"/>
                  </a:ext>
                </a:extLst>
              </a:tr>
              <a:tr h="634921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 ± 1.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5 ± 0.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05856693"/>
                  </a:ext>
                </a:extLst>
              </a:tr>
              <a:tr h="1095891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: 12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: 2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: 11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: 3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93613114"/>
                  </a:ext>
                </a:extLst>
              </a:tr>
              <a:tr h="1095891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hnicity*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casian: 36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rican-American: 3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ian: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casian: 51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rican-American: 0</a:t>
                      </a:r>
                    </a:p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ian: 1</a:t>
                      </a:r>
                    </a:p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6913668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14F8733-E327-4DC9-A1AE-EE2967AA540D}"/>
              </a:ext>
            </a:extLst>
          </p:cNvPr>
          <p:cNvSpPr txBox="1"/>
          <p:nvPr/>
        </p:nvSpPr>
        <p:spPr>
          <a:xfrm>
            <a:off x="363984" y="257452"/>
            <a:ext cx="2849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4</a:t>
            </a:r>
          </a:p>
        </p:txBody>
      </p:sp>
    </p:spTree>
    <p:extLst>
      <p:ext uri="{BB962C8B-B14F-4D97-AF65-F5344CB8AC3E}">
        <p14:creationId xmlns:p14="http://schemas.microsoft.com/office/powerpoint/2010/main" val="4229569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44C4570-4F48-452B-956D-F384DE0886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0094373"/>
              </p:ext>
            </p:extLst>
          </p:nvPr>
        </p:nvGraphicFramePr>
        <p:xfrm>
          <a:off x="65088" y="1411288"/>
          <a:ext cx="5603875" cy="4783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Worksheet" r:id="rId3" imgW="8259934" imgH="7048528" progId="Excel.Sheet.12">
                  <p:embed/>
                </p:oleObj>
              </mc:Choice>
              <mc:Fallback>
                <p:oleObj name="Worksheet" r:id="rId3" imgW="8259934" imgH="7048528" progId="Excel.Shee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27E9E56F-CA39-4ABC-ACC0-C786248C6A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088" y="1411288"/>
                        <a:ext cx="5603875" cy="4783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67FA0F5-310D-41E8-953D-4ED4DF653F16}"/>
              </a:ext>
            </a:extLst>
          </p:cNvPr>
          <p:cNvSpPr txBox="1"/>
          <p:nvPr/>
        </p:nvSpPr>
        <p:spPr>
          <a:xfrm>
            <a:off x="5669302" y="2334830"/>
            <a:ext cx="8533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Quartile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E818B27-0FD7-4FB0-B7C3-A6D3FAF81A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4892215"/>
              </p:ext>
            </p:extLst>
          </p:nvPr>
        </p:nvGraphicFramePr>
        <p:xfrm>
          <a:off x="6522697" y="1411287"/>
          <a:ext cx="5603875" cy="4783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Worksheet" r:id="rId5" imgW="8259934" imgH="7048528" progId="Excel.Sheet.12">
                  <p:embed/>
                </p:oleObj>
              </mc:Choice>
              <mc:Fallback>
                <p:oleObj name="Worksheet" r:id="rId5" imgW="8259934" imgH="7048528" progId="Excel.Shee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44C4570-4F48-452B-956D-F384DE0886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522697" y="1411287"/>
                        <a:ext cx="5603875" cy="4783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E4E31CED-1160-470A-9314-B53A3EB7ECF3}"/>
              </a:ext>
            </a:extLst>
          </p:cNvPr>
          <p:cNvSpPr txBox="1"/>
          <p:nvPr/>
        </p:nvSpPr>
        <p:spPr>
          <a:xfrm>
            <a:off x="363984" y="257452"/>
            <a:ext cx="2849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AD724F-93F1-44CF-A3A2-6B4CB118E063}"/>
              </a:ext>
            </a:extLst>
          </p:cNvPr>
          <p:cNvSpPr txBox="1"/>
          <p:nvPr/>
        </p:nvSpPr>
        <p:spPr>
          <a:xfrm>
            <a:off x="8235243" y="950197"/>
            <a:ext cx="24257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rs2065418 TT high ISS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C5721A4-6C9F-4646-8AFB-44384B3A9826}"/>
              </a:ext>
            </a:extLst>
          </p:cNvPr>
          <p:cNvSpPr txBox="1"/>
          <p:nvPr/>
        </p:nvSpPr>
        <p:spPr>
          <a:xfrm>
            <a:off x="2428721" y="950197"/>
            <a:ext cx="932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01B694B-29AA-4C3C-94D6-FCEFDDFFB867}"/>
              </a:ext>
            </a:extLst>
          </p:cNvPr>
          <p:cNvSpPr/>
          <p:nvPr/>
        </p:nvSpPr>
        <p:spPr>
          <a:xfrm>
            <a:off x="65088" y="1722268"/>
            <a:ext cx="5603875" cy="9942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B0FA127-071C-44B6-8EC9-50520C012740}"/>
              </a:ext>
            </a:extLst>
          </p:cNvPr>
          <p:cNvSpPr/>
          <p:nvPr/>
        </p:nvSpPr>
        <p:spPr>
          <a:xfrm>
            <a:off x="6522697" y="1722268"/>
            <a:ext cx="5603875" cy="9942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6FEBA06-1477-4DB3-8F03-DB32B9AD815E}"/>
              </a:ext>
            </a:extLst>
          </p:cNvPr>
          <p:cNvSpPr/>
          <p:nvPr/>
        </p:nvSpPr>
        <p:spPr>
          <a:xfrm>
            <a:off x="4755702" y="5584055"/>
            <a:ext cx="913261" cy="25745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ED9DF4E-91AE-44CD-BAF5-C18821E6EF43}"/>
              </a:ext>
            </a:extLst>
          </p:cNvPr>
          <p:cNvSpPr/>
          <p:nvPr/>
        </p:nvSpPr>
        <p:spPr>
          <a:xfrm>
            <a:off x="11209443" y="5584053"/>
            <a:ext cx="913261" cy="25745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67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7</Words>
  <Application>Microsoft Office PowerPoint</Application>
  <PresentationFormat>Widescreen</PresentationFormat>
  <Paragraphs>150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Microsoft Excel 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kas Schimunek</dc:creator>
  <cp:lastModifiedBy>Lukas Schimunek</cp:lastModifiedBy>
  <cp:revision>19</cp:revision>
  <dcterms:created xsi:type="dcterms:W3CDTF">2019-04-16T17:44:01Z</dcterms:created>
  <dcterms:modified xsi:type="dcterms:W3CDTF">2019-06-03T19:01:34Z</dcterms:modified>
</cp:coreProperties>
</file>